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25"/>
  </p:notesMasterIdLst>
  <p:sldIdLst>
    <p:sldId id="311" r:id="rId2"/>
    <p:sldId id="312" r:id="rId3"/>
    <p:sldId id="333" r:id="rId4"/>
    <p:sldId id="315" r:id="rId5"/>
    <p:sldId id="316" r:id="rId6"/>
    <p:sldId id="313" r:id="rId7"/>
    <p:sldId id="314" r:id="rId8"/>
    <p:sldId id="317" r:id="rId9"/>
    <p:sldId id="318" r:id="rId10"/>
    <p:sldId id="319" r:id="rId11"/>
    <p:sldId id="320" r:id="rId12"/>
    <p:sldId id="321" r:id="rId13"/>
    <p:sldId id="325" r:id="rId14"/>
    <p:sldId id="322" r:id="rId15"/>
    <p:sldId id="323" r:id="rId16"/>
    <p:sldId id="324" r:id="rId17"/>
    <p:sldId id="327" r:id="rId18"/>
    <p:sldId id="326" r:id="rId19"/>
    <p:sldId id="328" r:id="rId20"/>
    <p:sldId id="329" r:id="rId21"/>
    <p:sldId id="330" r:id="rId22"/>
    <p:sldId id="331" r:id="rId23"/>
    <p:sldId id="332" r:id="rId2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Yuji WADA" initials="YW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46" autoAdjust="0"/>
    <p:restoredTop sz="95904" autoAdjust="0"/>
  </p:normalViewPr>
  <p:slideViewPr>
    <p:cSldViewPr snapToGrid="0">
      <p:cViewPr varScale="1">
        <p:scale>
          <a:sx n="96" d="100"/>
          <a:sy n="96" d="100"/>
        </p:scale>
        <p:origin x="2088" y="19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commentAuthors" Target="commentAuthor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1EA391-2F9D-45A2-8AFA-B2ED832830BF}" type="datetimeFigureOut">
              <a:rPr kumimoji="1" lang="ja-JP" altLang="en-US" smtClean="0"/>
              <a:t>2024/12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1070BC3-17ED-466E-A388-A4100DF6EF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18577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73E34-631D-4A9A-9C0C-3ABDF13DC878}" type="datetimeFigureOut">
              <a:rPr kumimoji="1" lang="ja-JP" altLang="en-US" smtClean="0"/>
              <a:t>2024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D5110-BF39-46DA-AC5A-6984CF8C59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03388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73E34-631D-4A9A-9C0C-3ABDF13DC878}" type="datetimeFigureOut">
              <a:rPr kumimoji="1" lang="ja-JP" altLang="en-US" smtClean="0"/>
              <a:t>2024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D5110-BF39-46DA-AC5A-6984CF8C59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15447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73E34-631D-4A9A-9C0C-3ABDF13DC878}" type="datetimeFigureOut">
              <a:rPr kumimoji="1" lang="ja-JP" altLang="en-US" smtClean="0"/>
              <a:t>2024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D5110-BF39-46DA-AC5A-6984CF8C59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86115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73E34-631D-4A9A-9C0C-3ABDF13DC878}" type="datetimeFigureOut">
              <a:rPr kumimoji="1" lang="ja-JP" altLang="en-US" smtClean="0"/>
              <a:t>2024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D5110-BF39-46DA-AC5A-6984CF8C59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58899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73E34-631D-4A9A-9C0C-3ABDF13DC878}" type="datetimeFigureOut">
              <a:rPr kumimoji="1" lang="ja-JP" altLang="en-US" smtClean="0"/>
              <a:t>2024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D5110-BF39-46DA-AC5A-6984CF8C59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16203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73E34-631D-4A9A-9C0C-3ABDF13DC878}" type="datetimeFigureOut">
              <a:rPr kumimoji="1" lang="ja-JP" altLang="en-US" smtClean="0"/>
              <a:t>2024/12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D5110-BF39-46DA-AC5A-6984CF8C59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92189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73E34-631D-4A9A-9C0C-3ABDF13DC878}" type="datetimeFigureOut">
              <a:rPr kumimoji="1" lang="ja-JP" altLang="en-US" smtClean="0"/>
              <a:t>2024/12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D5110-BF39-46DA-AC5A-6984CF8C59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309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73E34-631D-4A9A-9C0C-3ABDF13DC878}" type="datetimeFigureOut">
              <a:rPr kumimoji="1" lang="ja-JP" altLang="en-US" smtClean="0"/>
              <a:t>2024/12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D5110-BF39-46DA-AC5A-6984CF8C59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03986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73E34-631D-4A9A-9C0C-3ABDF13DC878}" type="datetimeFigureOut">
              <a:rPr kumimoji="1" lang="ja-JP" altLang="en-US" smtClean="0"/>
              <a:t>2024/12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D5110-BF39-46DA-AC5A-6984CF8C59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32446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73E34-631D-4A9A-9C0C-3ABDF13DC878}" type="datetimeFigureOut">
              <a:rPr kumimoji="1" lang="ja-JP" altLang="en-US" smtClean="0"/>
              <a:t>2024/12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D5110-BF39-46DA-AC5A-6984CF8C59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70157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73E34-631D-4A9A-9C0C-3ABDF13DC878}" type="datetimeFigureOut">
              <a:rPr kumimoji="1" lang="ja-JP" altLang="en-US" smtClean="0"/>
              <a:t>2024/12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D5110-BF39-46DA-AC5A-6984CF8C59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08688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A73E34-631D-4A9A-9C0C-3ABDF13DC878}" type="datetimeFigureOut">
              <a:rPr kumimoji="1" lang="ja-JP" altLang="en-US" smtClean="0"/>
              <a:t>2024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5D5110-BF39-46DA-AC5A-6984CF8C59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8972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768D22A4-D070-9594-732F-447708AB9B4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400" y="0"/>
            <a:ext cx="6807200" cy="990600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D919684-BAAC-E309-D33A-A96AE80A24F6}"/>
              </a:ext>
            </a:extLst>
          </p:cNvPr>
          <p:cNvSpPr txBox="1"/>
          <p:nvPr/>
        </p:nvSpPr>
        <p:spPr>
          <a:xfrm>
            <a:off x="0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 Figure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4FAFA22-E793-47A8-A52B-22917F1C9666}"/>
              </a:ext>
            </a:extLst>
          </p:cNvPr>
          <p:cNvSpPr txBox="1"/>
          <p:nvPr/>
        </p:nvSpPr>
        <p:spPr>
          <a:xfrm>
            <a:off x="0" y="729593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UL128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A2248ED-5266-3068-E834-2EA21186CF1E}"/>
              </a:ext>
            </a:extLst>
          </p:cNvPr>
          <p:cNvSpPr txBox="1"/>
          <p:nvPr/>
        </p:nvSpPr>
        <p:spPr>
          <a:xfrm>
            <a:off x="4121426" y="0"/>
            <a:ext cx="2711174" cy="729593"/>
          </a:xfrm>
          <a:prstGeom prst="rect">
            <a:avLst/>
          </a:prstGeom>
          <a:noFill/>
        </p:spPr>
        <p:txBody>
          <a:bodyPr wrap="none" lIns="90000" rtlCol="0" anchor="ctr">
            <a:no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○ Japanese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●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Japanese isolates (partial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□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■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partial)</a:t>
            </a:r>
          </a:p>
        </p:txBody>
      </p:sp>
    </p:spTree>
    <p:extLst>
      <p:ext uri="{BB962C8B-B14F-4D97-AF65-F5344CB8AC3E}">
        <p14:creationId xmlns:p14="http://schemas.microsoft.com/office/powerpoint/2010/main" val="187431697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56E156F-F96D-450A-D76B-B2D8320C92E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3644983C-B728-E597-DAB2-70DEB63C136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57187"/>
            <a:ext cx="6858000" cy="9191625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2911532-DA23-1A5E-856A-DA97A11B40E3}"/>
              </a:ext>
            </a:extLst>
          </p:cNvPr>
          <p:cNvSpPr txBox="1"/>
          <p:nvPr/>
        </p:nvSpPr>
        <p:spPr>
          <a:xfrm>
            <a:off x="0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 Figure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03C70BA-854B-DE45-055B-9760C61B6E8E}"/>
              </a:ext>
            </a:extLst>
          </p:cNvPr>
          <p:cNvSpPr txBox="1"/>
          <p:nvPr/>
        </p:nvSpPr>
        <p:spPr>
          <a:xfrm>
            <a:off x="0" y="729593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UL142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7A30E5E-A50F-A78D-941D-868E53A7D334}"/>
              </a:ext>
            </a:extLst>
          </p:cNvPr>
          <p:cNvSpPr txBox="1"/>
          <p:nvPr/>
        </p:nvSpPr>
        <p:spPr>
          <a:xfrm>
            <a:off x="0" y="1143714"/>
            <a:ext cx="2711174" cy="729593"/>
          </a:xfrm>
          <a:prstGeom prst="rect">
            <a:avLst/>
          </a:prstGeom>
          <a:noFill/>
        </p:spPr>
        <p:txBody>
          <a:bodyPr wrap="none" lIns="90000" rtlCol="0" anchor="ctr">
            <a:no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○ Japanese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●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Japanese isolates (partial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□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■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partial)</a:t>
            </a:r>
          </a:p>
        </p:txBody>
      </p:sp>
    </p:spTree>
    <p:extLst>
      <p:ext uri="{BB962C8B-B14F-4D97-AF65-F5344CB8AC3E}">
        <p14:creationId xmlns:p14="http://schemas.microsoft.com/office/powerpoint/2010/main" val="228724051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4BD00CB-9029-4EFA-F1E3-DE1780B0B18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63A56DBA-EAEC-0FED-4D1F-6069CFB05D5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71500"/>
            <a:ext cx="6858000" cy="933450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BF0EA23E-F994-31C1-20BE-96397521FBAE}"/>
              </a:ext>
            </a:extLst>
          </p:cNvPr>
          <p:cNvSpPr txBox="1"/>
          <p:nvPr/>
        </p:nvSpPr>
        <p:spPr>
          <a:xfrm>
            <a:off x="0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 Figure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15E62F7-882A-040F-0599-A730A2A05198}"/>
              </a:ext>
            </a:extLst>
          </p:cNvPr>
          <p:cNvSpPr txBox="1"/>
          <p:nvPr/>
        </p:nvSpPr>
        <p:spPr>
          <a:xfrm>
            <a:off x="0" y="729593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UL141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FE4CCEC-0689-903D-4BAC-A88BC95DD99A}"/>
              </a:ext>
            </a:extLst>
          </p:cNvPr>
          <p:cNvSpPr txBox="1"/>
          <p:nvPr/>
        </p:nvSpPr>
        <p:spPr>
          <a:xfrm>
            <a:off x="0" y="1143714"/>
            <a:ext cx="2711174" cy="729593"/>
          </a:xfrm>
          <a:prstGeom prst="rect">
            <a:avLst/>
          </a:prstGeom>
          <a:noFill/>
        </p:spPr>
        <p:txBody>
          <a:bodyPr wrap="none" lIns="90000" rtlCol="0" anchor="ctr">
            <a:no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○ Japanese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●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Japanese isolates (partial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□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■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partial)</a:t>
            </a:r>
          </a:p>
        </p:txBody>
      </p:sp>
    </p:spTree>
    <p:extLst>
      <p:ext uri="{BB962C8B-B14F-4D97-AF65-F5344CB8AC3E}">
        <p14:creationId xmlns:p14="http://schemas.microsoft.com/office/powerpoint/2010/main" val="232296948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0DFE95C-8DBB-3842-B006-E4AB8FD8CEC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5A10362D-CE91-D807-63CD-518E86F9CD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4000" y="0"/>
            <a:ext cx="6604000" cy="990600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B7833FBE-5BE8-886B-7D2B-0F2A55EDFEC3}"/>
              </a:ext>
            </a:extLst>
          </p:cNvPr>
          <p:cNvSpPr txBox="1"/>
          <p:nvPr/>
        </p:nvSpPr>
        <p:spPr>
          <a:xfrm>
            <a:off x="0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 Figure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BB95EE4-5A19-6C3A-A314-F8F873E970C4}"/>
              </a:ext>
            </a:extLst>
          </p:cNvPr>
          <p:cNvSpPr txBox="1"/>
          <p:nvPr/>
        </p:nvSpPr>
        <p:spPr>
          <a:xfrm>
            <a:off x="0" y="729593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UL140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DECED73-0B73-0244-0752-4478438AEAB2}"/>
              </a:ext>
            </a:extLst>
          </p:cNvPr>
          <p:cNvSpPr txBox="1"/>
          <p:nvPr/>
        </p:nvSpPr>
        <p:spPr>
          <a:xfrm>
            <a:off x="119270" y="8811610"/>
            <a:ext cx="2711174" cy="729593"/>
          </a:xfrm>
          <a:prstGeom prst="rect">
            <a:avLst/>
          </a:prstGeom>
          <a:noFill/>
        </p:spPr>
        <p:txBody>
          <a:bodyPr wrap="none" lIns="90000" rtlCol="0" anchor="ctr">
            <a:no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○ Japanese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●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Japanese isolates (partial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□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■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partial)</a:t>
            </a:r>
          </a:p>
        </p:txBody>
      </p:sp>
    </p:spTree>
    <p:extLst>
      <p:ext uri="{BB962C8B-B14F-4D97-AF65-F5344CB8AC3E}">
        <p14:creationId xmlns:p14="http://schemas.microsoft.com/office/powerpoint/2010/main" val="384160302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9088FB1-4AB3-69F6-22F2-0AB9991C9AF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745A4242-C5D6-554F-E3AD-89915552464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007" y="0"/>
            <a:ext cx="6791985" cy="990600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D1FBF2D-BA78-143F-F841-4906FAC21F9F}"/>
              </a:ext>
            </a:extLst>
          </p:cNvPr>
          <p:cNvSpPr txBox="1"/>
          <p:nvPr/>
        </p:nvSpPr>
        <p:spPr>
          <a:xfrm>
            <a:off x="0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 Figure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F460B11-59E7-C526-517E-F39F5DA2C7A8}"/>
              </a:ext>
            </a:extLst>
          </p:cNvPr>
          <p:cNvSpPr txBox="1"/>
          <p:nvPr/>
        </p:nvSpPr>
        <p:spPr>
          <a:xfrm>
            <a:off x="0" y="729593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UL139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F5BA3E9-DEDC-9CA3-848A-CDFDD5DD65A5}"/>
              </a:ext>
            </a:extLst>
          </p:cNvPr>
          <p:cNvSpPr txBox="1"/>
          <p:nvPr/>
        </p:nvSpPr>
        <p:spPr>
          <a:xfrm>
            <a:off x="0" y="1143714"/>
            <a:ext cx="2711174" cy="729593"/>
          </a:xfrm>
          <a:prstGeom prst="rect">
            <a:avLst/>
          </a:prstGeom>
          <a:noFill/>
        </p:spPr>
        <p:txBody>
          <a:bodyPr wrap="none" lIns="90000" rtlCol="0" anchor="ctr">
            <a:no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○ Japanese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●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Japanese isolates (partial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□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■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partial)</a:t>
            </a:r>
          </a:p>
        </p:txBody>
      </p:sp>
    </p:spTree>
    <p:extLst>
      <p:ext uri="{BB962C8B-B14F-4D97-AF65-F5344CB8AC3E}">
        <p14:creationId xmlns:p14="http://schemas.microsoft.com/office/powerpoint/2010/main" val="375297393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1DD4808-0FAF-F26A-0C78-5EA46FA0F8C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B530C124-68AA-07C8-C416-D9BD515F18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2859" y="0"/>
            <a:ext cx="6475141" cy="990600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B4B65427-8B31-F8AC-F398-987EB49B3F25}"/>
              </a:ext>
            </a:extLst>
          </p:cNvPr>
          <p:cNvSpPr txBox="1"/>
          <p:nvPr/>
        </p:nvSpPr>
        <p:spPr>
          <a:xfrm>
            <a:off x="0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 Figure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BFE2D81-AE3F-704F-C078-4550FEFF204B}"/>
              </a:ext>
            </a:extLst>
          </p:cNvPr>
          <p:cNvSpPr txBox="1"/>
          <p:nvPr/>
        </p:nvSpPr>
        <p:spPr>
          <a:xfrm>
            <a:off x="0" y="729593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UL138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A549CED-0930-BA61-DAB6-FE6B3046ECC9}"/>
              </a:ext>
            </a:extLst>
          </p:cNvPr>
          <p:cNvSpPr txBox="1"/>
          <p:nvPr/>
        </p:nvSpPr>
        <p:spPr>
          <a:xfrm>
            <a:off x="0" y="8991741"/>
            <a:ext cx="2711174" cy="729593"/>
          </a:xfrm>
          <a:prstGeom prst="rect">
            <a:avLst/>
          </a:prstGeom>
          <a:noFill/>
        </p:spPr>
        <p:txBody>
          <a:bodyPr wrap="none" lIns="90000" rtlCol="0" anchor="ctr">
            <a:no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○ Japanese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●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Japanese isolates (partial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□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■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partial)</a:t>
            </a:r>
          </a:p>
        </p:txBody>
      </p:sp>
    </p:spTree>
    <p:extLst>
      <p:ext uri="{BB962C8B-B14F-4D97-AF65-F5344CB8AC3E}">
        <p14:creationId xmlns:p14="http://schemas.microsoft.com/office/powerpoint/2010/main" val="174869421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35689CD-05AF-FDF2-162D-60710F2391F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CDBDF31B-C021-733F-E79D-5700D68E60E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62350"/>
            <a:ext cx="6858000" cy="954365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8139E4F-65AB-EAEA-5887-679B77AC7B20}"/>
              </a:ext>
            </a:extLst>
          </p:cNvPr>
          <p:cNvSpPr txBox="1"/>
          <p:nvPr/>
        </p:nvSpPr>
        <p:spPr>
          <a:xfrm>
            <a:off x="0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 Figure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F9A0476-9E58-CA88-C845-29B172DDC347}"/>
              </a:ext>
            </a:extLst>
          </p:cNvPr>
          <p:cNvSpPr txBox="1"/>
          <p:nvPr/>
        </p:nvSpPr>
        <p:spPr>
          <a:xfrm>
            <a:off x="1236236" y="0"/>
            <a:ext cx="864339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UL136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5887EFC-B674-5CC9-F8D7-FC3BC0904B58}"/>
              </a:ext>
            </a:extLst>
          </p:cNvPr>
          <p:cNvSpPr txBox="1"/>
          <p:nvPr/>
        </p:nvSpPr>
        <p:spPr>
          <a:xfrm>
            <a:off x="0" y="494358"/>
            <a:ext cx="2711174" cy="729593"/>
          </a:xfrm>
          <a:prstGeom prst="rect">
            <a:avLst/>
          </a:prstGeom>
          <a:noFill/>
        </p:spPr>
        <p:txBody>
          <a:bodyPr wrap="none" lIns="90000" rtlCol="0" anchor="ctr">
            <a:no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○ Japanese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●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Japanese isolates (partial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□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■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partial)</a:t>
            </a:r>
          </a:p>
        </p:txBody>
      </p:sp>
    </p:spTree>
    <p:extLst>
      <p:ext uri="{BB962C8B-B14F-4D97-AF65-F5344CB8AC3E}">
        <p14:creationId xmlns:p14="http://schemas.microsoft.com/office/powerpoint/2010/main" val="316757569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163DE94-5AAB-7029-8B93-02EBA42AA99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0610513F-EBA6-FBD7-E2CC-6386553E817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06224"/>
            <a:ext cx="6858000" cy="9399776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FF3D426-C2B5-471B-2437-C80B04C1CDBD}"/>
              </a:ext>
            </a:extLst>
          </p:cNvPr>
          <p:cNvSpPr txBox="1"/>
          <p:nvPr/>
        </p:nvSpPr>
        <p:spPr>
          <a:xfrm>
            <a:off x="0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 Figure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9998F8A-E870-166F-C686-1382CD507D68}"/>
              </a:ext>
            </a:extLst>
          </p:cNvPr>
          <p:cNvSpPr txBox="1"/>
          <p:nvPr/>
        </p:nvSpPr>
        <p:spPr>
          <a:xfrm>
            <a:off x="0" y="729593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UL135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FF52157-F985-042D-A008-D0C761DE71AD}"/>
              </a:ext>
            </a:extLst>
          </p:cNvPr>
          <p:cNvSpPr txBox="1"/>
          <p:nvPr/>
        </p:nvSpPr>
        <p:spPr>
          <a:xfrm>
            <a:off x="3975652" y="184666"/>
            <a:ext cx="2711174" cy="729593"/>
          </a:xfrm>
          <a:prstGeom prst="rect">
            <a:avLst/>
          </a:prstGeom>
          <a:noFill/>
        </p:spPr>
        <p:txBody>
          <a:bodyPr wrap="none" lIns="90000" rtlCol="0" anchor="ctr">
            <a:no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○ Japanese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●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Japanese isolates (partial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□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■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partial)</a:t>
            </a:r>
          </a:p>
        </p:txBody>
      </p:sp>
    </p:spTree>
    <p:extLst>
      <p:ext uri="{BB962C8B-B14F-4D97-AF65-F5344CB8AC3E}">
        <p14:creationId xmlns:p14="http://schemas.microsoft.com/office/powerpoint/2010/main" val="349997514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8AE5EAC-10A9-173D-69B5-853F0BD9647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698F6B9D-42DE-3A29-7073-81A5ED47D3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100" y="0"/>
            <a:ext cx="6781800" cy="990600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BAB05D27-7606-F2C0-3867-B3F349B141CA}"/>
              </a:ext>
            </a:extLst>
          </p:cNvPr>
          <p:cNvSpPr txBox="1"/>
          <p:nvPr/>
        </p:nvSpPr>
        <p:spPr>
          <a:xfrm>
            <a:off x="0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 Figure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C4B54D9-732A-9ABD-3D76-DC026A4C4F0E}"/>
              </a:ext>
            </a:extLst>
          </p:cNvPr>
          <p:cNvSpPr txBox="1"/>
          <p:nvPr/>
        </p:nvSpPr>
        <p:spPr>
          <a:xfrm>
            <a:off x="0" y="729593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UL133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131F625-8684-C94B-87FA-33D79BEB80EC}"/>
              </a:ext>
            </a:extLst>
          </p:cNvPr>
          <p:cNvSpPr txBox="1"/>
          <p:nvPr/>
        </p:nvSpPr>
        <p:spPr>
          <a:xfrm>
            <a:off x="0" y="1143714"/>
            <a:ext cx="2711174" cy="729593"/>
          </a:xfrm>
          <a:prstGeom prst="rect">
            <a:avLst/>
          </a:prstGeom>
          <a:noFill/>
        </p:spPr>
        <p:txBody>
          <a:bodyPr wrap="none" lIns="90000" rtlCol="0" anchor="ctr">
            <a:no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○ Japanese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●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Japanese isolates (partial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□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■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partial)</a:t>
            </a:r>
          </a:p>
        </p:txBody>
      </p:sp>
    </p:spTree>
    <p:extLst>
      <p:ext uri="{BB962C8B-B14F-4D97-AF65-F5344CB8AC3E}">
        <p14:creationId xmlns:p14="http://schemas.microsoft.com/office/powerpoint/2010/main" val="422079194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908611F-EB4B-E5B7-F4D1-F83CFF9F6C8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1A4C8DFB-FC7A-FF94-813F-33338A2BB50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69332"/>
            <a:ext cx="6858000" cy="9495692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56AD2F7-D475-CB13-8BAA-C06D53294C45}"/>
              </a:ext>
            </a:extLst>
          </p:cNvPr>
          <p:cNvSpPr txBox="1"/>
          <p:nvPr/>
        </p:nvSpPr>
        <p:spPr>
          <a:xfrm>
            <a:off x="0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 Figure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257902D-2055-BE2A-33D4-B150FA423E11}"/>
              </a:ext>
            </a:extLst>
          </p:cNvPr>
          <p:cNvSpPr txBox="1"/>
          <p:nvPr/>
        </p:nvSpPr>
        <p:spPr>
          <a:xfrm>
            <a:off x="0" y="553998"/>
            <a:ext cx="1018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UL148A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5F651EE-51D9-073D-C8E0-B5DDD836BE94}"/>
              </a:ext>
            </a:extLst>
          </p:cNvPr>
          <p:cNvSpPr txBox="1"/>
          <p:nvPr/>
        </p:nvSpPr>
        <p:spPr>
          <a:xfrm>
            <a:off x="4146826" y="341822"/>
            <a:ext cx="2711174" cy="729593"/>
          </a:xfrm>
          <a:prstGeom prst="rect">
            <a:avLst/>
          </a:prstGeom>
          <a:noFill/>
        </p:spPr>
        <p:txBody>
          <a:bodyPr wrap="none" lIns="90000" rtlCol="0" anchor="ctr">
            <a:no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○ Japanese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●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Japanese isolates (partial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□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■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partial)</a:t>
            </a:r>
          </a:p>
        </p:txBody>
      </p:sp>
    </p:spTree>
    <p:extLst>
      <p:ext uri="{BB962C8B-B14F-4D97-AF65-F5344CB8AC3E}">
        <p14:creationId xmlns:p14="http://schemas.microsoft.com/office/powerpoint/2010/main" val="294818472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7DD623F-1796-129A-FFA3-B957C0C13E4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8F9C4947-2E95-E09B-8BCE-18F762A311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40288"/>
            <a:ext cx="6858000" cy="9065712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0555C52-24DF-E8D9-3B4B-E1B6B2B5A31A}"/>
              </a:ext>
            </a:extLst>
          </p:cNvPr>
          <p:cNvSpPr txBox="1"/>
          <p:nvPr/>
        </p:nvSpPr>
        <p:spPr>
          <a:xfrm>
            <a:off x="0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 Figure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611D481-241B-72C1-889E-31A1FB0883FC}"/>
              </a:ext>
            </a:extLst>
          </p:cNvPr>
          <p:cNvSpPr txBox="1"/>
          <p:nvPr/>
        </p:nvSpPr>
        <p:spPr>
          <a:xfrm>
            <a:off x="0" y="729593"/>
            <a:ext cx="1018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UL148B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B27E9AA-35BA-D29A-1F10-15A7DBDFAEDF}"/>
              </a:ext>
            </a:extLst>
          </p:cNvPr>
          <p:cNvSpPr txBox="1"/>
          <p:nvPr/>
        </p:nvSpPr>
        <p:spPr>
          <a:xfrm>
            <a:off x="0" y="1143714"/>
            <a:ext cx="2711174" cy="729593"/>
          </a:xfrm>
          <a:prstGeom prst="rect">
            <a:avLst/>
          </a:prstGeom>
          <a:noFill/>
        </p:spPr>
        <p:txBody>
          <a:bodyPr wrap="none" lIns="90000" rtlCol="0" anchor="ctr">
            <a:no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○ Japanese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●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Japanese isolates (partial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□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■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partial)</a:t>
            </a:r>
          </a:p>
        </p:txBody>
      </p:sp>
    </p:spTree>
    <p:extLst>
      <p:ext uri="{BB962C8B-B14F-4D97-AF65-F5344CB8AC3E}">
        <p14:creationId xmlns:p14="http://schemas.microsoft.com/office/powerpoint/2010/main" val="6360149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64B1752-2A01-BCFA-B0DB-609BED7F863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38256FF6-EEEC-6338-9FCC-2D77FBAB8BE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98056"/>
            <a:ext cx="6858000" cy="9207944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CD6F4A4A-2E9F-D4F5-F9E3-E5A25C026D89}"/>
              </a:ext>
            </a:extLst>
          </p:cNvPr>
          <p:cNvSpPr txBox="1"/>
          <p:nvPr/>
        </p:nvSpPr>
        <p:spPr>
          <a:xfrm>
            <a:off x="0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 Figure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4503B0C-DCCD-F188-D4A2-46306119C416}"/>
              </a:ext>
            </a:extLst>
          </p:cNvPr>
          <p:cNvSpPr txBox="1"/>
          <p:nvPr/>
        </p:nvSpPr>
        <p:spPr>
          <a:xfrm>
            <a:off x="0" y="729593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UL130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7663AAA-9543-05FB-4816-69D651C1609F}"/>
              </a:ext>
            </a:extLst>
          </p:cNvPr>
          <p:cNvSpPr txBox="1"/>
          <p:nvPr/>
        </p:nvSpPr>
        <p:spPr>
          <a:xfrm>
            <a:off x="0" y="1143714"/>
            <a:ext cx="2711174" cy="729593"/>
          </a:xfrm>
          <a:prstGeom prst="rect">
            <a:avLst/>
          </a:prstGeom>
          <a:noFill/>
        </p:spPr>
        <p:txBody>
          <a:bodyPr wrap="none" lIns="90000" rtlCol="0" anchor="ctr">
            <a:no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○ Japanese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●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Japanese isolates (partial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□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■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partial)</a:t>
            </a:r>
          </a:p>
        </p:txBody>
      </p:sp>
    </p:spTree>
    <p:extLst>
      <p:ext uri="{BB962C8B-B14F-4D97-AF65-F5344CB8AC3E}">
        <p14:creationId xmlns:p14="http://schemas.microsoft.com/office/powerpoint/2010/main" val="3872428404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E7D0076-DE6F-1E98-3324-D83451F6432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29C1D05B-1504-05F4-8F6F-13B297A742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9477" y="0"/>
            <a:ext cx="6679045" cy="990600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9F59484-EEC8-EB65-F4FA-E974F698704E}"/>
              </a:ext>
            </a:extLst>
          </p:cNvPr>
          <p:cNvSpPr txBox="1"/>
          <p:nvPr/>
        </p:nvSpPr>
        <p:spPr>
          <a:xfrm>
            <a:off x="0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 Figure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A2D82A9-5850-722D-2DEB-3763D2D6BEE2}"/>
              </a:ext>
            </a:extLst>
          </p:cNvPr>
          <p:cNvSpPr txBox="1"/>
          <p:nvPr/>
        </p:nvSpPr>
        <p:spPr>
          <a:xfrm>
            <a:off x="0" y="729593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UL148C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D182B50-98A7-8AC2-0084-9665F2774F86}"/>
              </a:ext>
            </a:extLst>
          </p:cNvPr>
          <p:cNvSpPr txBox="1"/>
          <p:nvPr/>
        </p:nvSpPr>
        <p:spPr>
          <a:xfrm>
            <a:off x="4057348" y="184666"/>
            <a:ext cx="2711174" cy="729593"/>
          </a:xfrm>
          <a:prstGeom prst="rect">
            <a:avLst/>
          </a:prstGeom>
          <a:noFill/>
        </p:spPr>
        <p:txBody>
          <a:bodyPr wrap="none" lIns="90000" rtlCol="0" anchor="ctr">
            <a:no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○ Japanese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●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Japanese isolates (partial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□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■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partial)</a:t>
            </a:r>
          </a:p>
        </p:txBody>
      </p:sp>
    </p:spTree>
    <p:extLst>
      <p:ext uri="{BB962C8B-B14F-4D97-AF65-F5344CB8AC3E}">
        <p14:creationId xmlns:p14="http://schemas.microsoft.com/office/powerpoint/2010/main" val="39544169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661CCC8-F1CB-9883-F36E-C56A3415A78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5575E4A0-21C4-48E3-03F9-B143D3F7093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62350"/>
            <a:ext cx="6858000" cy="954365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A7420F1-515B-6C1C-620A-F90090DAFDB3}"/>
              </a:ext>
            </a:extLst>
          </p:cNvPr>
          <p:cNvSpPr txBox="1"/>
          <p:nvPr/>
        </p:nvSpPr>
        <p:spPr>
          <a:xfrm>
            <a:off x="0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 Figure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9486E98-90B4-3FBA-DB55-1B704587EE8F}"/>
              </a:ext>
            </a:extLst>
          </p:cNvPr>
          <p:cNvSpPr txBox="1"/>
          <p:nvPr/>
        </p:nvSpPr>
        <p:spPr>
          <a:xfrm>
            <a:off x="0" y="729593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UL148D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B9FA667-E260-6EBE-7AB2-3D430514A85A}"/>
              </a:ext>
            </a:extLst>
          </p:cNvPr>
          <p:cNvSpPr txBox="1"/>
          <p:nvPr/>
        </p:nvSpPr>
        <p:spPr>
          <a:xfrm>
            <a:off x="0" y="1143714"/>
            <a:ext cx="2711174" cy="729593"/>
          </a:xfrm>
          <a:prstGeom prst="rect">
            <a:avLst/>
          </a:prstGeom>
          <a:noFill/>
        </p:spPr>
        <p:txBody>
          <a:bodyPr wrap="none" lIns="90000" rtlCol="0" anchor="ctr">
            <a:no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○ Japanese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●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Japanese isolates (partial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□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■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partial)</a:t>
            </a:r>
          </a:p>
        </p:txBody>
      </p:sp>
    </p:spTree>
    <p:extLst>
      <p:ext uri="{BB962C8B-B14F-4D97-AF65-F5344CB8AC3E}">
        <p14:creationId xmlns:p14="http://schemas.microsoft.com/office/powerpoint/2010/main" val="3303908113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EB40A14-596E-08C8-493E-3EA1BB5BC5E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15E05DCD-7B5E-50E5-1A5B-3A683E24EC9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400" y="0"/>
            <a:ext cx="6807200" cy="990600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37667EA-89E8-456C-6ED2-4ACC48B0B9EF}"/>
              </a:ext>
            </a:extLst>
          </p:cNvPr>
          <p:cNvSpPr txBox="1"/>
          <p:nvPr/>
        </p:nvSpPr>
        <p:spPr>
          <a:xfrm>
            <a:off x="0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 Figure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8881EA3-0EB0-5803-1574-AEA7E92493CE}"/>
              </a:ext>
            </a:extLst>
          </p:cNvPr>
          <p:cNvSpPr txBox="1"/>
          <p:nvPr/>
        </p:nvSpPr>
        <p:spPr>
          <a:xfrm>
            <a:off x="0" y="729593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UL150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D9D3D91-220F-6AB0-BD3A-380926E150B4}"/>
              </a:ext>
            </a:extLst>
          </p:cNvPr>
          <p:cNvSpPr txBox="1"/>
          <p:nvPr/>
        </p:nvSpPr>
        <p:spPr>
          <a:xfrm>
            <a:off x="4802809" y="-1"/>
            <a:ext cx="2055192" cy="1391479"/>
          </a:xfrm>
          <a:prstGeom prst="rect">
            <a:avLst/>
          </a:prstGeom>
          <a:noFill/>
        </p:spPr>
        <p:txBody>
          <a:bodyPr wrap="none" lIns="90000" rtlCol="0" anchor="ctr">
            <a:no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○ Japanese isolates</a:t>
            </a:r>
          </a:p>
          <a:p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   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●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Japanese isolates</a:t>
            </a:r>
          </a:p>
          <a:p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    (partial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□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</a:t>
            </a:r>
          </a:p>
          <a:p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   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■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</a:t>
            </a:r>
          </a:p>
          <a:p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    (partial)</a:t>
            </a:r>
          </a:p>
        </p:txBody>
      </p:sp>
    </p:spTree>
    <p:extLst>
      <p:ext uri="{BB962C8B-B14F-4D97-AF65-F5344CB8AC3E}">
        <p14:creationId xmlns:p14="http://schemas.microsoft.com/office/powerpoint/2010/main" val="4264265947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DA0E817-6FF1-9755-0007-8A7E4DBF77B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747BDC30-BBB4-93DA-6A5D-F6DE4DFB75E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2518" y="0"/>
            <a:ext cx="6645482" cy="990600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DDCDD29-F2B3-9723-FE62-C62A082BD628}"/>
              </a:ext>
            </a:extLst>
          </p:cNvPr>
          <p:cNvSpPr txBox="1"/>
          <p:nvPr/>
        </p:nvSpPr>
        <p:spPr>
          <a:xfrm>
            <a:off x="0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 Figure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B79B442-EE36-C537-6F60-2353E93F7601}"/>
              </a:ext>
            </a:extLst>
          </p:cNvPr>
          <p:cNvSpPr txBox="1"/>
          <p:nvPr/>
        </p:nvSpPr>
        <p:spPr>
          <a:xfrm>
            <a:off x="1355587" y="0"/>
            <a:ext cx="1018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UL150A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55113E7-25DB-E006-925A-ACF869212B65}"/>
              </a:ext>
            </a:extLst>
          </p:cNvPr>
          <p:cNvSpPr txBox="1"/>
          <p:nvPr/>
        </p:nvSpPr>
        <p:spPr>
          <a:xfrm>
            <a:off x="0" y="507609"/>
            <a:ext cx="2711174" cy="729593"/>
          </a:xfrm>
          <a:prstGeom prst="rect">
            <a:avLst/>
          </a:prstGeom>
          <a:noFill/>
        </p:spPr>
        <p:txBody>
          <a:bodyPr wrap="none" lIns="90000" rtlCol="0" anchor="ctr">
            <a:no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○ Japanese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●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Japanese isolates (partial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□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■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partial)</a:t>
            </a:r>
          </a:p>
        </p:txBody>
      </p:sp>
    </p:spTree>
    <p:extLst>
      <p:ext uri="{BB962C8B-B14F-4D97-AF65-F5344CB8AC3E}">
        <p14:creationId xmlns:p14="http://schemas.microsoft.com/office/powerpoint/2010/main" val="22725168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474D8E6-BAC4-CD55-7BCF-51EBBF6D7BF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5DC1777F-EB4D-8C96-9D54-2E36AB14AA5E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r="4541"/>
          <a:stretch/>
        </p:blipFill>
        <p:spPr>
          <a:xfrm>
            <a:off x="311426" y="729593"/>
            <a:ext cx="6546574" cy="914400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D06E0C4-3A41-FC06-C318-3F79FF785369}"/>
              </a:ext>
            </a:extLst>
          </p:cNvPr>
          <p:cNvSpPr txBox="1"/>
          <p:nvPr/>
        </p:nvSpPr>
        <p:spPr>
          <a:xfrm>
            <a:off x="0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 Figure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9B9B235-60F6-2BCB-6940-BE51825BD229}"/>
              </a:ext>
            </a:extLst>
          </p:cNvPr>
          <p:cNvSpPr txBox="1"/>
          <p:nvPr/>
        </p:nvSpPr>
        <p:spPr>
          <a:xfrm>
            <a:off x="0" y="729593"/>
            <a:ext cx="1018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UL131A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FFF0BE72-F487-A633-9AED-44A72FC84E73}"/>
              </a:ext>
            </a:extLst>
          </p:cNvPr>
          <p:cNvSpPr txBox="1"/>
          <p:nvPr/>
        </p:nvSpPr>
        <p:spPr>
          <a:xfrm>
            <a:off x="0" y="1143714"/>
            <a:ext cx="2711174" cy="729593"/>
          </a:xfrm>
          <a:prstGeom prst="rect">
            <a:avLst/>
          </a:prstGeom>
          <a:noFill/>
        </p:spPr>
        <p:txBody>
          <a:bodyPr wrap="none" lIns="90000" rtlCol="0" anchor="ctr">
            <a:no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○ Japanese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●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Japanese isolates (partial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□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■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partial)</a:t>
            </a:r>
          </a:p>
        </p:txBody>
      </p:sp>
    </p:spTree>
    <p:extLst>
      <p:ext uri="{BB962C8B-B14F-4D97-AF65-F5344CB8AC3E}">
        <p14:creationId xmlns:p14="http://schemas.microsoft.com/office/powerpoint/2010/main" val="8892838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18F3192-DB3C-E539-B69A-22EA9C2D17C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31BC9E89-DDAD-55A5-B9AF-A1E512B445D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4000" y="0"/>
            <a:ext cx="6604000" cy="990600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72DC883-A7E8-BA3B-30FC-3D6521AD0255}"/>
              </a:ext>
            </a:extLst>
          </p:cNvPr>
          <p:cNvSpPr txBox="1"/>
          <p:nvPr/>
        </p:nvSpPr>
        <p:spPr>
          <a:xfrm>
            <a:off x="0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 Figure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4C70242-39FD-6BE2-F3EC-FE3D58CAB4B9}"/>
              </a:ext>
            </a:extLst>
          </p:cNvPr>
          <p:cNvSpPr txBox="1"/>
          <p:nvPr/>
        </p:nvSpPr>
        <p:spPr>
          <a:xfrm>
            <a:off x="1490236" y="0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UL132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C64E6D4-FF0C-CC6F-BEFF-2E82B1D54B92}"/>
              </a:ext>
            </a:extLst>
          </p:cNvPr>
          <p:cNvSpPr txBox="1"/>
          <p:nvPr/>
        </p:nvSpPr>
        <p:spPr>
          <a:xfrm>
            <a:off x="0" y="549462"/>
            <a:ext cx="2711174" cy="729593"/>
          </a:xfrm>
          <a:prstGeom prst="rect">
            <a:avLst/>
          </a:prstGeom>
          <a:noFill/>
        </p:spPr>
        <p:txBody>
          <a:bodyPr wrap="none" lIns="90000" rtlCol="0" anchor="ctr">
            <a:no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○ Japanese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●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Japanese isolates (partial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□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■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partial)</a:t>
            </a:r>
          </a:p>
        </p:txBody>
      </p:sp>
    </p:spTree>
    <p:extLst>
      <p:ext uri="{BB962C8B-B14F-4D97-AF65-F5344CB8AC3E}">
        <p14:creationId xmlns:p14="http://schemas.microsoft.com/office/powerpoint/2010/main" val="35141213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B57CD71-EEAB-428C-A078-D7471A2C6EB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1DC9B246-BA4E-390E-8CE5-CC05435215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450" y="0"/>
            <a:ext cx="6769100" cy="990600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93A1BD5-B7BE-B5F6-C427-F064DBE68394}"/>
              </a:ext>
            </a:extLst>
          </p:cNvPr>
          <p:cNvSpPr txBox="1"/>
          <p:nvPr/>
        </p:nvSpPr>
        <p:spPr>
          <a:xfrm>
            <a:off x="0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 Figure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E6B672B-8E8E-4B1F-B369-2ECA32BA188D}"/>
              </a:ext>
            </a:extLst>
          </p:cNvPr>
          <p:cNvSpPr txBox="1"/>
          <p:nvPr/>
        </p:nvSpPr>
        <p:spPr>
          <a:xfrm>
            <a:off x="0" y="729593"/>
            <a:ext cx="1018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UL147A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E46A31A-5C59-3161-618D-75D613AA3052}"/>
              </a:ext>
            </a:extLst>
          </p:cNvPr>
          <p:cNvSpPr txBox="1"/>
          <p:nvPr/>
        </p:nvSpPr>
        <p:spPr>
          <a:xfrm>
            <a:off x="0" y="1143714"/>
            <a:ext cx="2711174" cy="729593"/>
          </a:xfrm>
          <a:prstGeom prst="rect">
            <a:avLst/>
          </a:prstGeom>
          <a:noFill/>
        </p:spPr>
        <p:txBody>
          <a:bodyPr wrap="none" lIns="90000" rtlCol="0" anchor="ctr">
            <a:no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○ Japanese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●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Japanese isolates (partial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□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■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partial)</a:t>
            </a:r>
          </a:p>
        </p:txBody>
      </p:sp>
    </p:spTree>
    <p:extLst>
      <p:ext uri="{BB962C8B-B14F-4D97-AF65-F5344CB8AC3E}">
        <p14:creationId xmlns:p14="http://schemas.microsoft.com/office/powerpoint/2010/main" val="10490027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E2B2AF4-7D21-D013-97E9-4E9388A30C6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A22D5711-55EA-8955-ABDE-E3A142F1012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8793" y="0"/>
            <a:ext cx="6580414" cy="990600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73F19D4-CFF6-C1CB-D0E6-6ABF177D67AD}"/>
              </a:ext>
            </a:extLst>
          </p:cNvPr>
          <p:cNvSpPr txBox="1"/>
          <p:nvPr/>
        </p:nvSpPr>
        <p:spPr>
          <a:xfrm>
            <a:off x="0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 Figure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9744C0B-B0FB-A383-51F7-28B468ADC59E}"/>
              </a:ext>
            </a:extLst>
          </p:cNvPr>
          <p:cNvSpPr txBox="1"/>
          <p:nvPr/>
        </p:nvSpPr>
        <p:spPr>
          <a:xfrm>
            <a:off x="1563756" y="17859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UL147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10F8552-EFB3-398F-104F-9DEBADDE51E5}"/>
              </a:ext>
            </a:extLst>
          </p:cNvPr>
          <p:cNvSpPr txBox="1"/>
          <p:nvPr/>
        </p:nvSpPr>
        <p:spPr>
          <a:xfrm>
            <a:off x="0" y="405050"/>
            <a:ext cx="2711174" cy="729593"/>
          </a:xfrm>
          <a:prstGeom prst="rect">
            <a:avLst/>
          </a:prstGeom>
          <a:noFill/>
        </p:spPr>
        <p:txBody>
          <a:bodyPr wrap="none" lIns="90000" rtlCol="0" anchor="ctr">
            <a:no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○ Japanese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●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Japanese isolates (partial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□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■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partial)</a:t>
            </a:r>
          </a:p>
        </p:txBody>
      </p:sp>
    </p:spTree>
    <p:extLst>
      <p:ext uri="{BB962C8B-B14F-4D97-AF65-F5344CB8AC3E}">
        <p14:creationId xmlns:p14="http://schemas.microsoft.com/office/powerpoint/2010/main" val="27551430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5FAD5C2-C401-311E-D17C-5172E5F520D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973EFF17-570A-6A02-074B-CB86C45FCC4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28863"/>
            <a:ext cx="6858000" cy="9577137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366E0EB-3733-1A7F-3292-ACC50391A959}"/>
              </a:ext>
            </a:extLst>
          </p:cNvPr>
          <p:cNvSpPr txBox="1"/>
          <p:nvPr/>
        </p:nvSpPr>
        <p:spPr>
          <a:xfrm>
            <a:off x="0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 Figure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31B444F-AA86-6524-27F0-DD98F2513B3A}"/>
              </a:ext>
            </a:extLst>
          </p:cNvPr>
          <p:cNvSpPr txBox="1"/>
          <p:nvPr/>
        </p:nvSpPr>
        <p:spPr>
          <a:xfrm>
            <a:off x="0" y="729593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UL146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C60D469-BBBF-AA9F-ACD9-CD9A5797E406}"/>
              </a:ext>
            </a:extLst>
          </p:cNvPr>
          <p:cNvSpPr txBox="1"/>
          <p:nvPr/>
        </p:nvSpPr>
        <p:spPr>
          <a:xfrm>
            <a:off x="0" y="1143714"/>
            <a:ext cx="2711174" cy="729593"/>
          </a:xfrm>
          <a:prstGeom prst="rect">
            <a:avLst/>
          </a:prstGeom>
          <a:noFill/>
        </p:spPr>
        <p:txBody>
          <a:bodyPr wrap="none" lIns="90000" rtlCol="0" anchor="ctr">
            <a:no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○ Japanese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●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Japanese isolates (partial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□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■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partial)</a:t>
            </a:r>
          </a:p>
        </p:txBody>
      </p:sp>
    </p:spTree>
    <p:extLst>
      <p:ext uri="{BB962C8B-B14F-4D97-AF65-F5344CB8AC3E}">
        <p14:creationId xmlns:p14="http://schemas.microsoft.com/office/powerpoint/2010/main" val="401450148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31E6E9A-6C09-ABC4-AA7C-C48FC5ACDA8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B53C44B0-9463-9EA0-EF4B-3F22205F46F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26330"/>
            <a:ext cx="6858000" cy="937967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1EFBF60-1BEF-EDC4-67F6-93305556577D}"/>
              </a:ext>
            </a:extLst>
          </p:cNvPr>
          <p:cNvSpPr txBox="1"/>
          <p:nvPr/>
        </p:nvSpPr>
        <p:spPr>
          <a:xfrm>
            <a:off x="0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 Figure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B1FCE9F-FDB5-8D26-C503-1269511036C0}"/>
              </a:ext>
            </a:extLst>
          </p:cNvPr>
          <p:cNvSpPr txBox="1"/>
          <p:nvPr/>
        </p:nvSpPr>
        <p:spPr>
          <a:xfrm>
            <a:off x="0" y="411401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UL145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1358F2D-5C55-A9CB-7FF4-819319B343E6}"/>
              </a:ext>
            </a:extLst>
          </p:cNvPr>
          <p:cNvSpPr txBox="1"/>
          <p:nvPr/>
        </p:nvSpPr>
        <p:spPr>
          <a:xfrm>
            <a:off x="0" y="780733"/>
            <a:ext cx="2711174" cy="729593"/>
          </a:xfrm>
          <a:prstGeom prst="rect">
            <a:avLst/>
          </a:prstGeom>
          <a:noFill/>
        </p:spPr>
        <p:txBody>
          <a:bodyPr wrap="none" lIns="90000" rtlCol="0" anchor="ctr">
            <a:no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○ Japanese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●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Japanese isolates (partial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□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■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partial)</a:t>
            </a:r>
          </a:p>
        </p:txBody>
      </p:sp>
    </p:spTree>
    <p:extLst>
      <p:ext uri="{BB962C8B-B14F-4D97-AF65-F5344CB8AC3E}">
        <p14:creationId xmlns:p14="http://schemas.microsoft.com/office/powerpoint/2010/main" val="60997301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2167062-9B56-F1CF-C9C7-77288C764CB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6471DAA8-2F36-9D43-BFA6-464C6A8A62C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074" y="0"/>
            <a:ext cx="6751851" cy="990600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5C91B3B-8F60-C162-5805-C125421A0330}"/>
              </a:ext>
            </a:extLst>
          </p:cNvPr>
          <p:cNvSpPr txBox="1"/>
          <p:nvPr/>
        </p:nvSpPr>
        <p:spPr>
          <a:xfrm>
            <a:off x="0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 Figure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0934142-061C-B0CC-1988-CA9A2E1B6F80}"/>
              </a:ext>
            </a:extLst>
          </p:cNvPr>
          <p:cNvSpPr txBox="1"/>
          <p:nvPr/>
        </p:nvSpPr>
        <p:spPr>
          <a:xfrm>
            <a:off x="0" y="729593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UL144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CE8A63A-CE54-A5E4-3335-FBAAE6CD7A3F}"/>
              </a:ext>
            </a:extLst>
          </p:cNvPr>
          <p:cNvSpPr txBox="1"/>
          <p:nvPr/>
        </p:nvSpPr>
        <p:spPr>
          <a:xfrm>
            <a:off x="0" y="1143714"/>
            <a:ext cx="2711174" cy="729593"/>
          </a:xfrm>
          <a:prstGeom prst="rect">
            <a:avLst/>
          </a:prstGeom>
          <a:noFill/>
        </p:spPr>
        <p:txBody>
          <a:bodyPr wrap="none" lIns="90000" rtlCol="0" anchor="ctr">
            <a:no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○ Japanese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●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Japanese isolates (partial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□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complete)</a:t>
            </a:r>
          </a:p>
          <a:p>
            <a:r>
              <a:rPr lang="ja-JP" altLang="en-US" sz="105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■</a:t>
            </a:r>
            <a:r>
              <a:rPr lang="en-US" altLang="ja-JP" sz="10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hinese and Korean isolates (partial)</a:t>
            </a:r>
          </a:p>
        </p:txBody>
      </p:sp>
    </p:spTree>
    <p:extLst>
      <p:ext uri="{BB962C8B-B14F-4D97-AF65-F5344CB8AC3E}">
        <p14:creationId xmlns:p14="http://schemas.microsoft.com/office/powerpoint/2010/main" val="16341339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>
          <a:defRPr kumimoji="1" sz="1200" b="1" dirty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9613</TotalTime>
  <Words>717</Words>
  <Application>Microsoft Macintosh PowerPoint</Application>
  <PresentationFormat>A4 210 x 297 mm</PresentationFormat>
  <Paragraphs>142</Paragraphs>
  <Slides>2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3</vt:i4>
      </vt:variant>
    </vt:vector>
  </HeadingPairs>
  <TitlesOfParts>
    <vt:vector size="28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uji WADA</dc:creator>
  <cp:lastModifiedBy>Yuji Wada</cp:lastModifiedBy>
  <cp:revision>605</cp:revision>
  <cp:lastPrinted>2023-01-24T05:40:56Z</cp:lastPrinted>
  <dcterms:created xsi:type="dcterms:W3CDTF">2020-02-19T06:54:27Z</dcterms:created>
  <dcterms:modified xsi:type="dcterms:W3CDTF">2024-12-13T02:58:59Z</dcterms:modified>
</cp:coreProperties>
</file>